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90" d="100"/>
          <a:sy n="90" d="100"/>
        </p:scale>
        <p:origin x="398" y="-3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EE199C-94DA-493F-B67B-5626EF621E80}" type="datetimeFigureOut">
              <a:rPr lang="de-DE" smtClean="0"/>
              <a:t>29.03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2E07AD-1A6A-4A75-9DC3-917EF574293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428825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EE199C-94DA-493F-B67B-5626EF621E80}" type="datetimeFigureOut">
              <a:rPr lang="de-DE" smtClean="0"/>
              <a:t>29.03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2E07AD-1A6A-4A75-9DC3-917EF574293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680396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EE199C-94DA-493F-B67B-5626EF621E80}" type="datetimeFigureOut">
              <a:rPr lang="de-DE" smtClean="0"/>
              <a:t>29.03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2E07AD-1A6A-4A75-9DC3-917EF574293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446873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EE199C-94DA-493F-B67B-5626EF621E80}" type="datetimeFigureOut">
              <a:rPr lang="de-DE" smtClean="0"/>
              <a:t>29.03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2E07AD-1A6A-4A75-9DC3-917EF574293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254820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EE199C-94DA-493F-B67B-5626EF621E80}" type="datetimeFigureOut">
              <a:rPr lang="de-DE" smtClean="0"/>
              <a:t>29.03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2E07AD-1A6A-4A75-9DC3-917EF574293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996818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EE199C-94DA-493F-B67B-5626EF621E80}" type="datetimeFigureOut">
              <a:rPr lang="de-DE" smtClean="0"/>
              <a:t>29.03.202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2E07AD-1A6A-4A75-9DC3-917EF574293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893726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EE199C-94DA-493F-B67B-5626EF621E80}" type="datetimeFigureOut">
              <a:rPr lang="de-DE" smtClean="0"/>
              <a:t>29.03.2023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2E07AD-1A6A-4A75-9DC3-917EF574293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28988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EE199C-94DA-493F-B67B-5626EF621E80}" type="datetimeFigureOut">
              <a:rPr lang="de-DE" smtClean="0"/>
              <a:t>29.03.2023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2E07AD-1A6A-4A75-9DC3-917EF574293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729353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EE199C-94DA-493F-B67B-5626EF621E80}" type="datetimeFigureOut">
              <a:rPr lang="de-DE" smtClean="0"/>
              <a:t>29.03.2023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2E07AD-1A6A-4A75-9DC3-917EF574293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261461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EE199C-94DA-493F-B67B-5626EF621E80}" type="datetimeFigureOut">
              <a:rPr lang="de-DE" smtClean="0"/>
              <a:t>29.03.202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2E07AD-1A6A-4A75-9DC3-917EF574293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413874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EE199C-94DA-493F-B67B-5626EF621E80}" type="datetimeFigureOut">
              <a:rPr lang="de-DE" smtClean="0"/>
              <a:t>29.03.202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2E07AD-1A6A-4A75-9DC3-917EF574293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242979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EE199C-94DA-493F-B67B-5626EF621E80}" type="datetimeFigureOut">
              <a:rPr lang="de-DE" smtClean="0"/>
              <a:t>29.03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2E07AD-1A6A-4A75-9DC3-917EF574293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56162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afik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20238" y="236220"/>
            <a:ext cx="8496300" cy="5775960"/>
          </a:xfrm>
          <a:prstGeom prst="rect">
            <a:avLst/>
          </a:prstGeom>
        </p:spPr>
      </p:pic>
      <p:sp>
        <p:nvSpPr>
          <p:cNvPr id="6" name="Rechteck 5"/>
          <p:cNvSpPr/>
          <p:nvPr/>
        </p:nvSpPr>
        <p:spPr>
          <a:xfrm>
            <a:off x="820238" y="6012180"/>
            <a:ext cx="9627629" cy="7294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GB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 Table 1:</a:t>
            </a:r>
            <a:r>
              <a:rPr lang="en-GB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istribution of transport vehicles among days of the week for non-SARS-CoV-2 (top) and SARS-CoV-2 associated </a:t>
            </a:r>
            <a:r>
              <a:rPr lang="en-GB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ransports, </a:t>
            </a: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ivided according to the means of transport</a:t>
            </a:r>
            <a:r>
              <a:rPr lang="en-GB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bottom).</a:t>
            </a:r>
            <a:endParaRPr lang="de-DE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443566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3</Words>
  <Application>Microsoft Office PowerPoint</Application>
  <PresentationFormat>Breitbild</PresentationFormat>
  <Paragraphs>1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</vt:lpstr>
      <vt:lpstr>PowerPoint-Präsentation</vt:lpstr>
    </vt:vector>
  </TitlesOfParts>
  <Company>Universitätsklinikum Leipzig Aö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Bender, Katrin</dc:creator>
  <cp:lastModifiedBy>Bender, Katrin</cp:lastModifiedBy>
  <cp:revision>2</cp:revision>
  <dcterms:created xsi:type="dcterms:W3CDTF">2023-03-29T07:28:40Z</dcterms:created>
  <dcterms:modified xsi:type="dcterms:W3CDTF">2023-03-29T08:11:50Z</dcterms:modified>
</cp:coreProperties>
</file>